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2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9" userDrawn="1">
          <p15:clr>
            <a:srgbClr val="A4A3A4"/>
          </p15:clr>
        </p15:guide>
        <p15:guide id="2" pos="424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4C99B"/>
    <a:srgbClr val="D84B79"/>
    <a:srgbClr val="FF80A9"/>
    <a:srgbClr val="FFADD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862"/>
    <p:restoredTop sz="96190" autoAdjust="0"/>
  </p:normalViewPr>
  <p:slideViewPr>
    <p:cSldViewPr snapToGrid="0" snapToObjects="1">
      <p:cViewPr varScale="1">
        <p:scale>
          <a:sx n="83" d="100"/>
          <a:sy n="83" d="100"/>
        </p:scale>
        <p:origin x="3576" y="96"/>
      </p:cViewPr>
      <p:guideLst>
        <p:guide orient="horz" pos="3129"/>
        <p:guide pos="4247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96FFA8E-DC54-0F46-8537-5A5BBE0E0911}" type="datetimeFigureOut">
              <a:rPr kumimoji="1" lang="ja-JP" altLang="en-US" smtClean="0"/>
              <a:t>2021/6/2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0BF2260-5430-3041-B062-F77B978A95D2}" type="slidenum">
              <a:rPr kumimoji="1" lang="ja-JP" altLang="en-US" smtClean="0"/>
              <a:t>‹N°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62043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0BF2260-5430-3041-B062-F77B978A95D2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22289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CF7DB-0419-F44E-ABB0-0476EB5CA2F3}" type="datetimeFigureOut">
              <a:rPr kumimoji="1" lang="ja-JP" altLang="en-US" smtClean="0"/>
              <a:t>2021/6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2107E-3C2A-4C4F-A7BB-74167B51ABD5}" type="slidenum">
              <a:rPr kumimoji="1" lang="ja-JP" altLang="en-US" smtClean="0"/>
              <a:t>‹N°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33956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CF7DB-0419-F44E-ABB0-0476EB5CA2F3}" type="datetimeFigureOut">
              <a:rPr kumimoji="1" lang="ja-JP" altLang="en-US" smtClean="0"/>
              <a:t>2021/6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2107E-3C2A-4C4F-A7BB-74167B51ABD5}" type="slidenum">
              <a:rPr kumimoji="1" lang="ja-JP" altLang="en-US" smtClean="0"/>
              <a:t>‹N°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24353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CF7DB-0419-F44E-ABB0-0476EB5CA2F3}" type="datetimeFigureOut">
              <a:rPr kumimoji="1" lang="ja-JP" altLang="en-US" smtClean="0"/>
              <a:t>2021/6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2107E-3C2A-4C4F-A7BB-74167B51ABD5}" type="slidenum">
              <a:rPr kumimoji="1" lang="ja-JP" altLang="en-US" smtClean="0"/>
              <a:t>‹N°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86352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CF7DB-0419-F44E-ABB0-0476EB5CA2F3}" type="datetimeFigureOut">
              <a:rPr kumimoji="1" lang="ja-JP" altLang="en-US" smtClean="0"/>
              <a:t>2021/6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2107E-3C2A-4C4F-A7BB-74167B51ABD5}" type="slidenum">
              <a:rPr kumimoji="1" lang="ja-JP" altLang="en-US" smtClean="0"/>
              <a:t>‹N°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45065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CF7DB-0419-F44E-ABB0-0476EB5CA2F3}" type="datetimeFigureOut">
              <a:rPr kumimoji="1" lang="ja-JP" altLang="en-US" smtClean="0"/>
              <a:t>2021/6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2107E-3C2A-4C4F-A7BB-74167B51ABD5}" type="slidenum">
              <a:rPr kumimoji="1" lang="ja-JP" altLang="en-US" smtClean="0"/>
              <a:t>‹N°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3402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CF7DB-0419-F44E-ABB0-0476EB5CA2F3}" type="datetimeFigureOut">
              <a:rPr kumimoji="1" lang="ja-JP" altLang="en-US" smtClean="0"/>
              <a:t>2021/6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2107E-3C2A-4C4F-A7BB-74167B51ABD5}" type="slidenum">
              <a:rPr kumimoji="1" lang="ja-JP" altLang="en-US" smtClean="0"/>
              <a:t>‹N°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50365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CF7DB-0419-F44E-ABB0-0476EB5CA2F3}" type="datetimeFigureOut">
              <a:rPr kumimoji="1" lang="ja-JP" altLang="en-US" smtClean="0"/>
              <a:t>2021/6/2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2107E-3C2A-4C4F-A7BB-74167B51ABD5}" type="slidenum">
              <a:rPr kumimoji="1" lang="ja-JP" altLang="en-US" smtClean="0"/>
              <a:t>‹N°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00193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CF7DB-0419-F44E-ABB0-0476EB5CA2F3}" type="datetimeFigureOut">
              <a:rPr kumimoji="1" lang="ja-JP" altLang="en-US" smtClean="0"/>
              <a:t>2021/6/2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2107E-3C2A-4C4F-A7BB-74167B51ABD5}" type="slidenum">
              <a:rPr kumimoji="1" lang="ja-JP" altLang="en-US" smtClean="0"/>
              <a:t>‹N°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47126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CF7DB-0419-F44E-ABB0-0476EB5CA2F3}" type="datetimeFigureOut">
              <a:rPr kumimoji="1" lang="ja-JP" altLang="en-US" smtClean="0"/>
              <a:t>2021/6/2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2107E-3C2A-4C4F-A7BB-74167B51ABD5}" type="slidenum">
              <a:rPr kumimoji="1" lang="ja-JP" altLang="en-US" smtClean="0"/>
              <a:t>‹N°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62563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CF7DB-0419-F44E-ABB0-0476EB5CA2F3}" type="datetimeFigureOut">
              <a:rPr kumimoji="1" lang="ja-JP" altLang="en-US" smtClean="0"/>
              <a:t>2021/6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2107E-3C2A-4C4F-A7BB-74167B51ABD5}" type="slidenum">
              <a:rPr kumimoji="1" lang="ja-JP" altLang="en-US" smtClean="0"/>
              <a:t>‹N°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01215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FCF7DB-0419-F44E-ABB0-0476EB5CA2F3}" type="datetimeFigureOut">
              <a:rPr kumimoji="1" lang="ja-JP" altLang="en-US" smtClean="0"/>
              <a:t>2021/6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2107E-3C2A-4C4F-A7BB-74167B51ABD5}" type="slidenum">
              <a:rPr kumimoji="1" lang="ja-JP" altLang="en-US" smtClean="0"/>
              <a:t>‹N°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11309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FCF7DB-0419-F44E-ABB0-0476EB5CA2F3}" type="datetimeFigureOut">
              <a:rPr kumimoji="1" lang="ja-JP" altLang="en-US" smtClean="0"/>
              <a:t>2021/6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12107E-3C2A-4C4F-A7BB-74167B51ABD5}" type="slidenum">
              <a:rPr kumimoji="1" lang="ja-JP" altLang="en-US" smtClean="0"/>
              <a:t>‹N°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71200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12E6C6E6-7A28-CB43-A1A5-ED20F64171EC}"/>
              </a:ext>
            </a:extLst>
          </p:cNvPr>
          <p:cNvSpPr/>
          <p:nvPr/>
        </p:nvSpPr>
        <p:spPr>
          <a:xfrm>
            <a:off x="754380" y="2365523"/>
            <a:ext cx="5372100" cy="2862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b="1">
                <a:latin typeface="Helvetica"/>
                <a:cs typeface="Helvetica"/>
              </a:rPr>
              <a:t>PEDV</a:t>
            </a:r>
            <a:r>
              <a:rPr lang="en-US" altLang="ja-JP" sz="1000" b="1" dirty="0">
                <a:latin typeface="Helvetica"/>
                <a:cs typeface="Helvetica"/>
              </a:rPr>
              <a:t>/S(1-1320)+</a:t>
            </a:r>
            <a:r>
              <a:rPr lang="en-US" altLang="ja-JP" sz="1000" b="1" dirty="0" err="1">
                <a:latin typeface="Helvetica"/>
                <a:cs typeface="Helvetica"/>
              </a:rPr>
              <a:t>CMP+Tags</a:t>
            </a:r>
            <a:endParaRPr lang="en-US" altLang="ja-JP" sz="1000" kern="100" dirty="0">
              <a:latin typeface="Helvetica" pitchFamily="2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800" b="1" kern="100" dirty="0">
                <a:solidFill>
                  <a:schemeClr val="accent6">
                    <a:lumMod val="75000"/>
                  </a:schemeClr>
                </a:solidFill>
                <a:latin typeface="Helvetica" pitchFamily="2" charset="0"/>
                <a:ea typeface="游明朝" panose="02020400000000000000" pitchFamily="18" charset="-128"/>
                <a:cs typeface="Times New Roman" panose="02020603050405020304" pitchFamily="18" charset="0"/>
              </a:rPr>
              <a:t>MTPLIYFWLFLPVLLTLSLPQDVTRCQSTINFRRFFSKFNVQAPAVVVLGGYLPSMNSSSWYCGTGIETDSGVHGIFLSYIDSGQGFEIGISQEPFDPSGYQLYLHKATNGNTSAIARLRICQFPDNKTLGPTVNDVTTGRNCLFNKAIPALQDGKNIVVGITWDNDRVTVFADKIYHFYIKNDWSRVATRCYNKRSCAMQYVYTPTYYMLNVTSAGEDGIYYEPCTANCSGYAANVFATDSNGHIPEGFSFNNWFLLSNDSTLLHGKVVSNQPLLVNCLWAIPKIYGLGQFFSFNQTMDGVCNGAAAQRAPEALRFNINDTFVILAEGSIVLHTALGTNLSFVCSNSSDPHKAIFTIPLGVTEVPYYCFLKVDTYKSTVYKFLAVLPPTVKEIVITKYGDVYVNGFGYLHLGLLDAVTINFTGHGTDDDVSGFWTVASTNFVDALIEVQGTAIQRILYCDDPVSQLKCSQVSFDLDDGFYPISSRNLLSHEQPISFVTLPSFNDHSFVNITVSAAFGGHSGANLIASDTTINGFSSFCVDTRQFTITLFYNVTNSYGYVSKSQDSNCPFTLQSVNDYLSFSKFCVSTSLLAGACTIDLFGYPEFGSGVKFTSLYFQFTKGELITGTPKPLQGVTDVSFMTLDVCTKYTIYGFKGEGIITLTNSSFLAGVYYTSDSGQLLAFKNVTSGAVYSVTPCSFSEQAAYVDDDIVGVISSLSNSTFNNTRELPGFFYHSNDGSNCTEPVLVYSNIGVCKSGSIGYVPLQDGQVKIAPMVTGNISIPTNFSMSIRTEYLQLYNTPVSVDCVTYVCNGNSRCKQLLTQYTAACKTIESALQLSARLESVEVNSMLTISEEALQLATISSFNGDGYNFTNVLGVSVYDPASGRVVQKRSFIEDLLFNKVVTNGLGTVDEDYKRCSNGRSVADLVCAQYYSGVMVLPGVVDAEKLHMYSASLIGGMALGGLTTAAALPFSHAVQARLNYLALQTDVLQRNQQLLAESFNSAIGNITSAFESVKEAISQTSNGLNTVAHALTKVQEVVNSQGSALTQLTIQLQHNFQAISSSIDDIYSRLDILSADVQVDRLITGRLSALNAFVAQTLTKYTEVQASRKLAQQKVNECVKSQSQRYGFCGGDGEHIFSLVQAAPQGLLFLHTVLVPGDFVNVIAIDGLCVNGDIALTLREPGLVLFTHELQTYTATEYFVSSRRMFEPRKPTVSDFVQIESCVVTYVNLTSDQLPDVIPDYIDVNKTLDEILASLPNRIGPSLPLDVFNATYLNLTGEIADLEQRSESLRNTTEELRSLIYNINNTLVDLEWLNRVETYI</a:t>
            </a:r>
            <a:r>
              <a:rPr lang="en-US" altLang="ja-JP" sz="800" b="1" kern="100" dirty="0">
                <a:solidFill>
                  <a:schemeClr val="accent1">
                    <a:lumMod val="75000"/>
                  </a:schemeClr>
                </a:solidFill>
                <a:latin typeface="Helvetica" pitchFamily="2" charset="0"/>
                <a:ea typeface="游明朝" panose="02020400000000000000" pitchFamily="18" charset="-128"/>
                <a:cs typeface="Times New Roman" panose="02020603050405020304" pitchFamily="18" charset="0"/>
              </a:rPr>
              <a:t>EEDPCECKSIVKFQTKVEELINTLQQKLEAVAKRIEALENKII</a:t>
            </a:r>
            <a:r>
              <a:rPr lang="en-US" altLang="ja-JP" sz="800" kern="100" dirty="0">
                <a:latin typeface="Helvetica" pitchFamily="2" charset="0"/>
                <a:ea typeface="游明朝" panose="02020400000000000000" pitchFamily="18" charset="-128"/>
                <a:cs typeface="Times New Roman" panose="02020603050405020304" pitchFamily="18" charset="0"/>
              </a:rPr>
              <a:t>SSAGENLYFQGSSSHHHHHHHHGGGSAWSHPQFEKHHHHHHGGGSMKHKGS</a:t>
            </a:r>
          </a:p>
          <a:p>
            <a:endParaRPr lang="en-US" altLang="ja-JP" sz="800" kern="100" dirty="0">
              <a:latin typeface="Helvetica" pitchFamily="2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000" b="1" kern="100" dirty="0">
                <a:solidFill>
                  <a:schemeClr val="accent6">
                    <a:lumMod val="75000"/>
                  </a:schemeClr>
                </a:solidFill>
                <a:latin typeface="Helvetica" pitchFamily="2" charset="0"/>
                <a:ea typeface="游明朝" panose="02020400000000000000" pitchFamily="18" charset="-128"/>
                <a:cs typeface="Times New Roman" panose="02020603050405020304" pitchFamily="18" charset="0"/>
              </a:rPr>
              <a:t>- PEDV S</a:t>
            </a:r>
            <a:r>
              <a:rPr lang="en-US" altLang="ja-JP" sz="1000" b="1" kern="100" dirty="0">
                <a:latin typeface="Helvetica" pitchFamily="2" charset="0"/>
                <a:ea typeface="游明朝" panose="02020400000000000000" pitchFamily="18" charset="-128"/>
                <a:cs typeface="Times New Roman" panose="02020603050405020304" pitchFamily="18" charset="0"/>
              </a:rPr>
              <a:t> /</a:t>
            </a:r>
            <a:r>
              <a:rPr lang="en-US" altLang="ja-JP" sz="1000" kern="100" dirty="0">
                <a:latin typeface="Helvetica" pitchFamily="2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b="1" kern="100" dirty="0">
                <a:solidFill>
                  <a:schemeClr val="accent1">
                    <a:lumMod val="75000"/>
                  </a:schemeClr>
                </a:solidFill>
                <a:latin typeface="Helvetica" pitchFamily="2" charset="0"/>
                <a:ea typeface="游明朝" panose="02020400000000000000" pitchFamily="18" charset="-128"/>
                <a:cs typeface="Times New Roman" panose="02020603050405020304" pitchFamily="18" charset="0"/>
              </a:rPr>
              <a:t>- CMP</a:t>
            </a:r>
            <a:r>
              <a:rPr lang="en-US" altLang="ja-JP" sz="1000" b="1" kern="100" dirty="0">
                <a:latin typeface="Helvetica" pitchFamily="2" charset="0"/>
                <a:ea typeface="游明朝" panose="02020400000000000000" pitchFamily="18" charset="-128"/>
                <a:cs typeface="Times New Roman" panose="02020603050405020304" pitchFamily="18" charset="0"/>
              </a:rPr>
              <a:t> /</a:t>
            </a:r>
            <a:r>
              <a:rPr lang="en-US" altLang="ja-JP" sz="1000" kern="100" dirty="0">
                <a:latin typeface="Helvetica" pitchFamily="2" charset="0"/>
                <a:ea typeface="游明朝" panose="02020400000000000000" pitchFamily="18" charset="-128"/>
                <a:cs typeface="Times New Roman" panose="02020603050405020304" pitchFamily="18" charset="0"/>
              </a:rPr>
              <a:t> - Tags</a:t>
            </a:r>
            <a:endParaRPr lang="ja-JP" altLang="ja-JP" sz="1000" kern="100">
              <a:latin typeface="Helvetica" pitchFamily="2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92563041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 2007-2010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>
            <a:lumMod val="40000"/>
            <a:lumOff val="60000"/>
          </a:schemeClr>
        </a:solidFill>
        <a:effectLst/>
      </a:spPr>
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<a:prstTxWarp prst="textNoShape">
          <a:avLst/>
        </a:prstTxWarp>
        <a:noAutofit/>
      </a:bodyPr>
      <a:lstStyle>
        <a:defPPr algn="ctr">
          <a:defRPr kumimoji="1" sz="1400" dirty="0" err="1" smtClean="0">
            <a:latin typeface="Helvetica" pitchFamily="2" charset="0"/>
          </a:defRPr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>
        <a:effectLst/>
      </a:spPr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033</TotalTime>
  <Words>20</Words>
  <Application>Microsoft Office PowerPoint</Application>
  <PresentationFormat>Affichage à l'écran (4:3)</PresentationFormat>
  <Paragraphs>5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7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9" baseType="lpstr">
      <vt:lpstr>ＭＳ Ｐゴシック</vt:lpstr>
      <vt:lpstr>Yu Gothic</vt:lpstr>
      <vt:lpstr>游明朝</vt:lpstr>
      <vt:lpstr>Arial</vt:lpstr>
      <vt:lpstr>Calibri</vt:lpstr>
      <vt:lpstr>Helvetica</vt:lpstr>
      <vt:lpstr>Times New Roman</vt:lpstr>
      <vt:lpstr>ホワイト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suda akitsu</dc:creator>
  <cp:lastModifiedBy>Elodie Coulamy</cp:lastModifiedBy>
  <cp:revision>177</cp:revision>
  <dcterms:created xsi:type="dcterms:W3CDTF">2017-03-05T15:41:48Z</dcterms:created>
  <dcterms:modified xsi:type="dcterms:W3CDTF">2021-06-21T14:23:09Z</dcterms:modified>
</cp:coreProperties>
</file>